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44811-22A1-4F38-A35A-083D16B45F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595C4-9B93-4FE1-97EF-A28849AEB8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F4CB9-81BA-4B03-A0A5-F55B554A75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10078-B4CD-416C-BA32-D973FB5206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2F4B7-7095-44C9-87DC-42C6DB1FA1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9A9C8-5DF4-46C5-8BCC-734289042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E7BD5-1C57-417C-B0A5-5ADAFE5E7C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B01265-DBF5-465B-8A03-9E99F70B4B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F5286-1E94-4D22-9D34-03A9812EFE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7D738-882E-4CC0-9453-1B0B82BDB0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31C6B-EEE4-4766-A579-DA911B1A86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7395E-56DE-4DA6-AFAF-CB6C6ABF63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A40864-22ED-439F-BECA-7A0DC4F42D7B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6320" y="228600"/>
            <a:ext cx="9067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ADDITIONAL FILE 4.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Activity based protein profiling (ABPP) of normal male and female urines with different 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incubation times (5min, 30min, 90min), 37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°C, 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pH 9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20395" t="0" r="0" b="0"/>
          <a:stretch/>
        </p:blipFill>
        <p:spPr>
          <a:xfrm>
            <a:off x="2286000" y="907920"/>
            <a:ext cx="4759200" cy="57214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-92880" y="1279440"/>
            <a:ext cx="227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rine hydrolase ABP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-93240" y="3759120"/>
            <a:ext cx="24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Total protein, Sypro Rub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7T17:43:52Z</dcterms:created>
  <dc:creator>Winnipeg Regional Health Authority</dc:creator>
  <dc:description/>
  <dc:language>en-US</dc:language>
  <cp:lastModifiedBy>Winnipeg Regional Health Authority</cp:lastModifiedBy>
  <dcterms:modified xsi:type="dcterms:W3CDTF">2013-09-23T22:04:44Z</dcterms:modified>
  <cp:revision>549</cp:revision>
  <dc:subject/>
  <dc:title>NOVEL BIOMARKERS OF IFTA,  RENAL ALLOGRAFT DYSFUNCTION AND LOSS</dc:title>
</cp:coreProperties>
</file>